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20.06.2023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8" y="99951"/>
            <a:ext cx="7886700" cy="476123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l-time reverse transcription polymerase chain reaction (RT-PCR) verification of the RNA-Seq results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943600"/>
            <a:ext cx="8862822" cy="57607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for comparison in IR vs. SH are shown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ix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nes, whose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value lower 0.05, as well as two other genes were selected for PCR-analysis. Reference gene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was used to normalize PCR-results.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K:\Редактируемые\Для публикаций\0_текущие публикации\ишемия_2\кора\4 часа\статья\вар2\доп\зск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2172" y="1767840"/>
            <a:ext cx="6182443" cy="29248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57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2. Real-time reverse transcription polymerase chain reaction (RT-PCR) verification of the RNA-Seq results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7</cp:revision>
  <dcterms:created xsi:type="dcterms:W3CDTF">2023-01-16T11:00:34Z</dcterms:created>
  <dcterms:modified xsi:type="dcterms:W3CDTF">2023-06-20T09:30:37Z</dcterms:modified>
</cp:coreProperties>
</file>